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32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n-share-02\CAN-Proteomic$\Home\WardDG\Bladder%202015\MISEQ%20PROJECT\Titation%20expermeinents%20SW780-HBCLS%20TERT%2022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can-share-02\CAN-Proteomic$\Home\WardDG\Bladder%202015\MISEQ%20PROJECT\Titation%20expermeinents%20MGUH-BLOOD%20FGFR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5.3905784138342308E-2"/>
          <c:y val="1.7129879817654382E-2"/>
          <c:w val="0.91969593246282566"/>
          <c:h val="0.89851460146429052"/>
        </c:manualLayout>
      </c:layout>
      <c:scatterChart>
        <c:scatterStyle val="lineMarker"/>
        <c:ser>
          <c:idx val="0"/>
          <c:order val="0"/>
          <c:tx>
            <c:strRef>
              <c:f>Sheet1!$O$1</c:f>
              <c:strCache>
                <c:ptCount val="1"/>
                <c:pt idx="0">
                  <c:v>MEAN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</c:trendline>
          <c:errBars>
            <c:errDir val="y"/>
            <c:errBarType val="both"/>
            <c:errValType val="cust"/>
            <c:noEndCap val="1"/>
            <c:plus>
              <c:numRef>
                <c:f>Sheet1!$P$5:$P$12</c:f>
                <c:numCache>
                  <c:formatCode>General</c:formatCode>
                  <c:ptCount val="8"/>
                  <c:pt idx="0">
                    <c:v>2.0828983720878296</c:v>
                  </c:pt>
                  <c:pt idx="1">
                    <c:v>1.1008603605066625</c:v>
                  </c:pt>
                  <c:pt idx="2">
                    <c:v>1.3984693463383291</c:v>
                  </c:pt>
                  <c:pt idx="3">
                    <c:v>0.2664598225663854</c:v>
                  </c:pt>
                  <c:pt idx="4">
                    <c:v>0.17935841322121654</c:v>
                  </c:pt>
                  <c:pt idx="5">
                    <c:v>0.57591306008377563</c:v>
                  </c:pt>
                  <c:pt idx="6">
                    <c:v>0.12653989670038313</c:v>
                  </c:pt>
                  <c:pt idx="7">
                    <c:v>6.3023906297143967E-2</c:v>
                  </c:pt>
                </c:numCache>
              </c:numRef>
            </c:plus>
            <c:minus>
              <c:numRef>
                <c:f>Sheet1!$P$5:$P$12</c:f>
                <c:numCache>
                  <c:formatCode>General</c:formatCode>
                  <c:ptCount val="8"/>
                  <c:pt idx="0">
                    <c:v>2.0828983720878296</c:v>
                  </c:pt>
                  <c:pt idx="1">
                    <c:v>1.1008603605066625</c:v>
                  </c:pt>
                  <c:pt idx="2">
                    <c:v>1.3984693463383291</c:v>
                  </c:pt>
                  <c:pt idx="3">
                    <c:v>0.2664598225663854</c:v>
                  </c:pt>
                  <c:pt idx="4">
                    <c:v>0.17935841322121654</c:v>
                  </c:pt>
                  <c:pt idx="5">
                    <c:v>0.57591306008377563</c:v>
                  </c:pt>
                  <c:pt idx="6">
                    <c:v>0.12653989670038313</c:v>
                  </c:pt>
                  <c:pt idx="7">
                    <c:v>6.3023906297143967E-2</c:v>
                  </c:pt>
                </c:numCache>
              </c:numRef>
            </c:minus>
          </c:errBars>
          <c:xVal>
            <c:numRef>
              <c:f>Sheet1!$N$4:$N$12</c:f>
              <c:numCache>
                <c:formatCode>General</c:formatCode>
                <c:ptCount val="9"/>
                <c:pt idx="0">
                  <c:v>25</c:v>
                </c:pt>
                <c:pt idx="1">
                  <c:v>12.5</c:v>
                </c:pt>
                <c:pt idx="2">
                  <c:v>6.25</c:v>
                </c:pt>
                <c:pt idx="3">
                  <c:v>3.125</c:v>
                </c:pt>
                <c:pt idx="4">
                  <c:v>1.5625</c:v>
                </c:pt>
                <c:pt idx="5">
                  <c:v>0.78125</c:v>
                </c:pt>
                <c:pt idx="6">
                  <c:v>0.390625</c:v>
                </c:pt>
                <c:pt idx="7">
                  <c:v>0.1953125</c:v>
                </c:pt>
                <c:pt idx="8">
                  <c:v>0</c:v>
                </c:pt>
              </c:numCache>
            </c:numRef>
          </c:xVal>
          <c:yVal>
            <c:numRef>
              <c:f>Sheet1!$O$4:$O$12</c:f>
              <c:numCache>
                <c:formatCode>General</c:formatCode>
                <c:ptCount val="9"/>
                <c:pt idx="0">
                  <c:v>23.650407811197027</c:v>
                </c:pt>
                <c:pt idx="1">
                  <c:v>12.545514802214859</c:v>
                </c:pt>
                <c:pt idx="2">
                  <c:v>7.361164165827617</c:v>
                </c:pt>
                <c:pt idx="3">
                  <c:v>3.7739363710836571</c:v>
                </c:pt>
                <c:pt idx="4">
                  <c:v>1.5504226862089947</c:v>
                </c:pt>
                <c:pt idx="5">
                  <c:v>1.2631479551142586</c:v>
                </c:pt>
                <c:pt idx="6">
                  <c:v>0.91011139736993185</c:v>
                </c:pt>
                <c:pt idx="7">
                  <c:v>0.41945878792249908</c:v>
                </c:pt>
                <c:pt idx="8">
                  <c:v>0.32982722143293797</c:v>
                </c:pt>
              </c:numCache>
            </c:numRef>
          </c:yVal>
        </c:ser>
        <c:axId val="38476800"/>
        <c:axId val="59053568"/>
      </c:scatterChart>
      <c:valAx>
        <c:axId val="38476800"/>
        <c:scaling>
          <c:orientation val="minMax"/>
        </c:scaling>
        <c:axPos val="b"/>
        <c:numFmt formatCode="General" sourceLinked="1"/>
        <c:tickLblPos val="nextTo"/>
        <c:crossAx val="59053568"/>
        <c:crosses val="autoZero"/>
        <c:crossBetween val="midCat"/>
        <c:majorUnit val="10"/>
      </c:valAx>
      <c:valAx>
        <c:axId val="59053568"/>
        <c:scaling>
          <c:orientation val="minMax"/>
        </c:scaling>
        <c:axPos val="l"/>
        <c:numFmt formatCode="General" sourceLinked="1"/>
        <c:tickLblPos val="nextTo"/>
        <c:crossAx val="38476800"/>
        <c:crosses val="autoZero"/>
        <c:crossBetween val="midCat"/>
        <c:majorUnit val="10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>
        <c:manualLayout>
          <c:layoutTarget val="inner"/>
          <c:xMode val="edge"/>
          <c:yMode val="edge"/>
          <c:x val="0.26643285214348206"/>
          <c:y val="5.1400554097404488E-2"/>
          <c:w val="0.57226859142607178"/>
          <c:h val="0.8326195683872849"/>
        </c:manualLayout>
      </c:layout>
      <c:scatterChart>
        <c:scatterStyle val="lineMarker"/>
        <c:ser>
          <c:idx val="0"/>
          <c:order val="0"/>
          <c:spPr>
            <a:ln w="28575">
              <a:noFill/>
            </a:ln>
          </c:spPr>
          <c:trendline>
            <c:trendlineType val="linear"/>
          </c:trendline>
          <c:errBars>
            <c:errDir val="y"/>
            <c:errBarType val="both"/>
            <c:errValType val="cust"/>
            <c:noEndCap val="1"/>
            <c:plus>
              <c:numRef>
                <c:f>Sheet1!$P$4:$P$12</c:f>
                <c:numCache>
                  <c:formatCode>General</c:formatCode>
                  <c:ptCount val="9"/>
                  <c:pt idx="0">
                    <c:v>1.1298035802225717</c:v>
                  </c:pt>
                  <c:pt idx="1">
                    <c:v>1.070601823457676</c:v>
                  </c:pt>
                  <c:pt idx="2">
                    <c:v>0.34100171699944531</c:v>
                  </c:pt>
                  <c:pt idx="3">
                    <c:v>1.1763966218516153</c:v>
                  </c:pt>
                  <c:pt idx="4">
                    <c:v>0.4844497727144616</c:v>
                  </c:pt>
                  <c:pt idx="5">
                    <c:v>0.25224331538942879</c:v>
                  </c:pt>
                  <c:pt idx="6">
                    <c:v>0.12299054634127385</c:v>
                  </c:pt>
                  <c:pt idx="7">
                    <c:v>0.16694041452330116</c:v>
                  </c:pt>
                  <c:pt idx="8">
                    <c:v>6.6194304153743402E-2</c:v>
                  </c:pt>
                </c:numCache>
              </c:numRef>
            </c:plus>
            <c:minus>
              <c:numRef>
                <c:f>Sheet1!$P$4:$P$12</c:f>
                <c:numCache>
                  <c:formatCode>General</c:formatCode>
                  <c:ptCount val="9"/>
                  <c:pt idx="0">
                    <c:v>1.1298035802225717</c:v>
                  </c:pt>
                  <c:pt idx="1">
                    <c:v>1.070601823457676</c:v>
                  </c:pt>
                  <c:pt idx="2">
                    <c:v>0.34100171699944531</c:v>
                  </c:pt>
                  <c:pt idx="3">
                    <c:v>1.1763966218516153</c:v>
                  </c:pt>
                  <c:pt idx="4">
                    <c:v>0.4844497727144616</c:v>
                  </c:pt>
                  <c:pt idx="5">
                    <c:v>0.25224331538942879</c:v>
                  </c:pt>
                  <c:pt idx="6">
                    <c:v>0.12299054634127385</c:v>
                  </c:pt>
                  <c:pt idx="7">
                    <c:v>0.16694041452330116</c:v>
                  </c:pt>
                  <c:pt idx="8">
                    <c:v>6.6194304153743402E-2</c:v>
                  </c:pt>
                </c:numCache>
              </c:numRef>
            </c:minus>
          </c:errBars>
          <c:xVal>
            <c:numRef>
              <c:f>Sheet1!$M$4:$M$12</c:f>
              <c:numCache>
                <c:formatCode>General</c:formatCode>
                <c:ptCount val="9"/>
                <c:pt idx="0">
                  <c:v>25</c:v>
                </c:pt>
                <c:pt idx="1">
                  <c:v>12.5</c:v>
                </c:pt>
                <c:pt idx="2">
                  <c:v>6.25</c:v>
                </c:pt>
                <c:pt idx="3">
                  <c:v>3.125</c:v>
                </c:pt>
                <c:pt idx="4">
                  <c:v>1.5625</c:v>
                </c:pt>
                <c:pt idx="5">
                  <c:v>0.78125</c:v>
                </c:pt>
                <c:pt idx="6">
                  <c:v>0.390625</c:v>
                </c:pt>
                <c:pt idx="7">
                  <c:v>0.1953125</c:v>
                </c:pt>
                <c:pt idx="8">
                  <c:v>0</c:v>
                </c:pt>
              </c:numCache>
            </c:numRef>
          </c:xVal>
          <c:yVal>
            <c:numRef>
              <c:f>Sheet1!$O$4:$O$12</c:f>
              <c:numCache>
                <c:formatCode>General</c:formatCode>
                <c:ptCount val="9"/>
                <c:pt idx="0">
                  <c:v>24.871983987995204</c:v>
                </c:pt>
                <c:pt idx="1">
                  <c:v>13.134928348054695</c:v>
                </c:pt>
                <c:pt idx="2">
                  <c:v>5.9510863597763732</c:v>
                </c:pt>
                <c:pt idx="3">
                  <c:v>2.8093105956163433</c:v>
                </c:pt>
                <c:pt idx="4">
                  <c:v>2.0318213358446795</c:v>
                </c:pt>
                <c:pt idx="5">
                  <c:v>0.96936204534678028</c:v>
                </c:pt>
                <c:pt idx="6">
                  <c:v>0.82948733413105069</c:v>
                </c:pt>
                <c:pt idx="7">
                  <c:v>0.82035975332088562</c:v>
                </c:pt>
                <c:pt idx="8">
                  <c:v>0.65691628675493485</c:v>
                </c:pt>
              </c:numCache>
            </c:numRef>
          </c:yVal>
        </c:ser>
        <c:axId val="31951488"/>
        <c:axId val="31961472"/>
      </c:scatterChart>
      <c:valAx>
        <c:axId val="31951488"/>
        <c:scaling>
          <c:orientation val="minMax"/>
          <c:min val="0"/>
        </c:scaling>
        <c:axPos val="b"/>
        <c:numFmt formatCode="General" sourceLinked="1"/>
        <c:tickLblPos val="nextTo"/>
        <c:crossAx val="31961472"/>
        <c:crosses val="autoZero"/>
        <c:crossBetween val="midCat"/>
        <c:majorUnit val="10"/>
      </c:valAx>
      <c:valAx>
        <c:axId val="31961472"/>
        <c:scaling>
          <c:orientation val="minMax"/>
          <c:max val="30"/>
          <c:min val="0"/>
        </c:scaling>
        <c:axPos val="l"/>
        <c:numFmt formatCode="General" sourceLinked="1"/>
        <c:tickLblPos val="nextTo"/>
        <c:crossAx val="31951488"/>
        <c:crosses val="autoZero"/>
        <c:crossBetween val="midCat"/>
        <c:majorUnit val="10"/>
      </c:valAx>
    </c:plotArea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45461-CC0D-4974-B428-90438C08472A}" type="datetimeFigureOut">
              <a:rPr lang="en-GB" smtClean="0"/>
              <a:t>18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AD1FE7-8625-4759-A4E4-69270C24EEBC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/>
          <p:nvPr/>
        </p:nvGraphicFramePr>
        <p:xfrm>
          <a:off x="1796637" y="5111112"/>
          <a:ext cx="3912914" cy="34892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/>
          <p:nvPr/>
        </p:nvGraphicFramePr>
        <p:xfrm>
          <a:off x="404664" y="395536"/>
          <a:ext cx="5544616" cy="3744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844824" y="179512"/>
            <a:ext cx="3176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MGH-U3 titration: </a:t>
            </a:r>
            <a:r>
              <a:rPr lang="en-GB" i="1" dirty="0" smtClean="0"/>
              <a:t>FGFR3</a:t>
            </a:r>
            <a:r>
              <a:rPr lang="en-GB" dirty="0" smtClean="0"/>
              <a:t> Y375C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 rot="16200000">
            <a:off x="474053" y="6662851"/>
            <a:ext cx="16707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% Mutant reads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2924944" y="8604448"/>
            <a:ext cx="1580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% Mutant DNA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2636912" y="3923928"/>
            <a:ext cx="1580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% Mutant DNA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474053" y="1910323"/>
            <a:ext cx="16707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% Mutant reads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1484784" y="4644008"/>
            <a:ext cx="4752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W-780 titration: </a:t>
            </a:r>
            <a:r>
              <a:rPr lang="en-GB" i="1" dirty="0" smtClean="0"/>
              <a:t>TERT</a:t>
            </a:r>
            <a:r>
              <a:rPr lang="en-GB" dirty="0" smtClean="0"/>
              <a:t> </a:t>
            </a:r>
            <a:r>
              <a:rPr lang="en-GB" dirty="0" err="1" smtClean="0"/>
              <a:t>promotor</a:t>
            </a:r>
            <a:r>
              <a:rPr lang="en-GB" dirty="0" smtClean="0"/>
              <a:t> (chr5:1295228)</a:t>
            </a: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5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Birmingha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rddg</dc:creator>
  <cp:lastModifiedBy>warddg</cp:lastModifiedBy>
  <cp:revision>2</cp:revision>
  <dcterms:created xsi:type="dcterms:W3CDTF">2015-12-18T11:22:14Z</dcterms:created>
  <dcterms:modified xsi:type="dcterms:W3CDTF">2015-12-18T11:31:09Z</dcterms:modified>
</cp:coreProperties>
</file>